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6" r:id="rId1"/>
  </p:sldMasterIdLst>
  <p:notesMasterIdLst>
    <p:notesMasterId r:id="rId3"/>
  </p:notesMasterIdLst>
  <p:sldIdLst>
    <p:sldId id="282" r:id="rId2"/>
  </p:sldIdLst>
  <p:sldSz cx="6858000" cy="9906000" type="A4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C61C"/>
    <a:srgbClr val="DAC1E1"/>
    <a:srgbClr val="B07FC0"/>
    <a:srgbClr val="DCD31E"/>
    <a:srgbClr val="EBE56B"/>
    <a:srgbClr val="F4F48E"/>
    <a:srgbClr val="40ECE8"/>
    <a:srgbClr val="8BF1F1"/>
    <a:srgbClr val="CA3A3A"/>
    <a:srgbClr val="D9737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96" autoAdjust="0"/>
    <p:restoredTop sz="86323" autoAdjust="0"/>
  </p:normalViewPr>
  <p:slideViewPr>
    <p:cSldViewPr snapToGrid="0">
      <p:cViewPr varScale="1">
        <p:scale>
          <a:sx n="91" d="100"/>
          <a:sy n="91" d="100"/>
        </p:scale>
        <p:origin x="328" y="184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95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C029C1-9C52-4F2F-AB88-2A88053D977F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DFBF56-2EF8-4548-9B5A-46433DCDF3F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5739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9967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449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1651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9098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7130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174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331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1509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023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987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334FF-CFC1-4A5B-920B-9EA4E1163AC9}" type="datetimeFigureOut">
              <a:rPr lang="en-GB" smtClean="0"/>
              <a:t>03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DA4CB-496B-4F28-8D32-CF0FCE9222D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6870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A2B21-3FCD-4721-B95C-427943F61125}" type="datetime1">
              <a:rPr lang="en-US" smtClean="0"/>
              <a:t>8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7E4EF-A1BD-40F4-AB7B-04F084DD991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880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7" r:id="rId1"/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/>
          <p:cNvSpPr txBox="1"/>
          <p:nvPr/>
        </p:nvSpPr>
        <p:spPr>
          <a:xfrm>
            <a:off x="307727" y="201150"/>
            <a:ext cx="6242545" cy="265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25" dirty="0"/>
              <a:t>MOVIE 1</a:t>
            </a:r>
          </a:p>
        </p:txBody>
      </p:sp>
      <p:sp>
        <p:nvSpPr>
          <p:cNvPr id="3" name="CaixaDeTexto 2">
            <a:extLst>
              <a:ext uri="{FF2B5EF4-FFF2-40B4-BE49-F238E27FC236}">
                <a16:creationId xmlns:a16="http://schemas.microsoft.com/office/drawing/2014/main" id="{84108ED2-CE7D-36CD-C07B-1DBE1A49C81C}"/>
              </a:ext>
            </a:extLst>
          </p:cNvPr>
          <p:cNvSpPr txBox="1"/>
          <p:nvPr/>
        </p:nvSpPr>
        <p:spPr>
          <a:xfrm>
            <a:off x="429047" y="810670"/>
            <a:ext cx="3186132" cy="26161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GB" sz="1100" dirty="0">
                <a:solidFill>
                  <a:srgbClr val="C32C5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  <a:r>
              <a:rPr lang="en-GB" sz="11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</a:t>
            </a:r>
            <a:r>
              <a:rPr lang="en-GB" sz="1100" dirty="0">
                <a:solidFill>
                  <a:srgbClr val="9DBA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43</a:t>
            </a:r>
            <a:r>
              <a:rPr lang="en-GB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</a:t>
            </a:r>
            <a:r>
              <a:rPr lang="en-GB" sz="1100" i="1" dirty="0">
                <a:solidFill>
                  <a:srgbClr val="C2AAA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. albicans</a:t>
            </a:r>
          </a:p>
        </p:txBody>
      </p:sp>
      <p:pic>
        <p:nvPicPr>
          <p:cNvPr id="4" name="Composite-1 ca cx phal 25">
            <a:hlinkClick r:id="" action="ppaction://media"/>
            <a:extLst>
              <a:ext uri="{FF2B5EF4-FFF2-40B4-BE49-F238E27FC236}">
                <a16:creationId xmlns:a16="http://schemas.microsoft.com/office/drawing/2014/main" id="{4D9B3313-B4E9-BC79-B9E1-DF82F91290C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r="17443"/>
          <a:stretch/>
        </p:blipFill>
        <p:spPr>
          <a:xfrm>
            <a:off x="429047" y="1130985"/>
            <a:ext cx="3185244" cy="2479903"/>
          </a:xfrm>
          <a:prstGeom prst="rect">
            <a:avLst/>
          </a:prstGeom>
          <a:ln w="38100" cap="sq">
            <a:noFill/>
            <a:prstDash val="solid"/>
            <a:miter lim="800000"/>
          </a:ln>
          <a:effectLst/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33D29332-5951-3694-8F7F-26C6038D59ED}"/>
              </a:ext>
            </a:extLst>
          </p:cNvPr>
          <p:cNvSpPr txBox="1"/>
          <p:nvPr/>
        </p:nvSpPr>
        <p:spPr>
          <a:xfrm>
            <a:off x="264605" y="4125925"/>
            <a:ext cx="6328789" cy="9451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VIE 1| </a:t>
            </a:r>
          </a:p>
          <a:p>
            <a:pPr algn="l"/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3-Dimensional </a:t>
            </a:r>
            <a:r>
              <a:rPr lang="pt-PT" sz="11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ndering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f Confocal </a:t>
            </a:r>
            <a:r>
              <a:rPr lang="pt-PT" sz="11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Micrographs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pt-PT" sz="11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maris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oftware. </a:t>
            </a:r>
            <a:r>
              <a:rPr lang="pt-PT" sz="11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 </a:t>
            </a:r>
            <a:r>
              <a:rPr lang="pt-PT" sz="1100" b="0" i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lbicans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(</a:t>
            </a:r>
            <a:r>
              <a:rPr lang="pt-PT" sz="11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beige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pt-PT" sz="11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halloidin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pt-PT" sz="11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), Cx43 (green). </a:t>
            </a:r>
            <a:r>
              <a:rPr lang="pt-PT" sz="1100" b="0" i="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ar, 5 </a:t>
            </a:r>
            <a:r>
              <a:rPr lang="el-GR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pt-PT" sz="11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500736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o Office">
  <a:themeElements>
    <a:clrScheme name="Personalizado 5">
      <a:dk1>
        <a:sysClr val="windowText" lastClr="000000"/>
      </a:dk1>
      <a:lt1>
        <a:sysClr val="window" lastClr="FFFFFF"/>
      </a:lt1>
      <a:dk2>
        <a:srgbClr val="505046"/>
      </a:dk2>
      <a:lt2>
        <a:srgbClr val="EEECE1"/>
      </a:lt2>
      <a:accent1>
        <a:srgbClr val="E28BB9"/>
      </a:accent1>
      <a:accent2>
        <a:srgbClr val="E38998"/>
      </a:accent2>
      <a:accent3>
        <a:srgbClr val="FF6699"/>
      </a:accent3>
      <a:accent4>
        <a:srgbClr val="E188B8"/>
      </a:accent4>
      <a:accent5>
        <a:srgbClr val="F75C75"/>
      </a:accent5>
      <a:accent6>
        <a:srgbClr val="F84FAA"/>
      </a:accent6>
      <a:hlink>
        <a:srgbClr val="CC9900"/>
      </a:hlink>
      <a:folHlink>
        <a:srgbClr val="666699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08</TotalTime>
  <Words>40</Words>
  <Application>Microsoft Macintosh PowerPoint</Application>
  <PresentationFormat>Papel A4 (210x297 mm)</PresentationFormat>
  <Paragraphs>4</Paragraphs>
  <Slides>1</Slides>
  <Notes>0</Notes>
  <HiddenSlides>0</HiddenSlides>
  <MMClips>1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Beatriz Cristóvão</dc:creator>
  <cp:lastModifiedBy>Henrique Girao</cp:lastModifiedBy>
  <cp:revision>94</cp:revision>
  <dcterms:created xsi:type="dcterms:W3CDTF">2022-01-12T14:31:08Z</dcterms:created>
  <dcterms:modified xsi:type="dcterms:W3CDTF">2023-08-03T09:55:36Z</dcterms:modified>
</cp:coreProperties>
</file>